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18000663" cy="14039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1599DDD-7F66-401A-A836-1FC74D5C6595}" v="9" dt="2023-11-23T09:25:36.0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 snapToGrid="0">
      <p:cViewPr varScale="1">
        <p:scale>
          <a:sx n="55" d="100"/>
          <a:sy n="55" d="100"/>
        </p:scale>
        <p:origin x="139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C1599DDD-7F66-401A-A836-1FC74D5C6595}"/>
    <pc:docChg chg="custSel addSld delSld modSld">
      <pc:chgData name="Alejandro Jimènez Melèndez" userId="3e26fc24-ba38-4df5-8524-b018042eb462" providerId="ADAL" clId="{C1599DDD-7F66-401A-A836-1FC74D5C6595}" dt="2023-11-23T09:26:06.211" v="79" actId="1076"/>
      <pc:docMkLst>
        <pc:docMk/>
      </pc:docMkLst>
      <pc:sldChg chg="addSp delSp modSp mod">
        <pc:chgData name="Alejandro Jimènez Melèndez" userId="3e26fc24-ba38-4df5-8524-b018042eb462" providerId="ADAL" clId="{C1599DDD-7F66-401A-A836-1FC74D5C6595}" dt="2023-11-23T09:26:06.211" v="79" actId="1076"/>
        <pc:sldMkLst>
          <pc:docMk/>
          <pc:sldMk cId="3246200346" sldId="260"/>
        </pc:sldMkLst>
        <pc:spChg chg="add mod">
          <ac:chgData name="Alejandro Jimènez Melèndez" userId="3e26fc24-ba38-4df5-8524-b018042eb462" providerId="ADAL" clId="{C1599DDD-7F66-401A-A836-1FC74D5C6595}" dt="2023-11-22T09:53:21.066" v="50" actId="20577"/>
          <ac:spMkLst>
            <pc:docMk/>
            <pc:sldMk cId="3246200346" sldId="260"/>
            <ac:spMk id="2" creationId="{B79A0502-A30B-49C2-92DE-44A96E049F78}"/>
          </ac:spMkLst>
        </pc:spChg>
        <pc:spChg chg="add mod">
          <ac:chgData name="Alejandro Jimènez Melèndez" userId="3e26fc24-ba38-4df5-8524-b018042eb462" providerId="ADAL" clId="{C1599DDD-7F66-401A-A836-1FC74D5C6595}" dt="2023-11-23T09:25:49.673" v="77" actId="1076"/>
          <ac:spMkLst>
            <pc:docMk/>
            <pc:sldMk cId="3246200346" sldId="260"/>
            <ac:spMk id="3" creationId="{8F4E425C-AB48-6285-9AA6-7AF824ED8798}"/>
          </ac:spMkLst>
        </pc:spChg>
        <pc:spChg chg="add del mod">
          <ac:chgData name="Alejandro Jimènez Melèndez" userId="3e26fc24-ba38-4df5-8524-b018042eb462" providerId="ADAL" clId="{C1599DDD-7F66-401A-A836-1FC74D5C6595}" dt="2023-11-23T09:25:45.823" v="76" actId="478"/>
          <ac:spMkLst>
            <pc:docMk/>
            <pc:sldMk cId="3246200346" sldId="260"/>
            <ac:spMk id="52" creationId="{491E6943-EE41-F4AE-4B69-FD733CCE98D7}"/>
          </ac:spMkLst>
        </pc:spChg>
        <pc:spChg chg="add del mod">
          <ac:chgData name="Alejandro Jimènez Melèndez" userId="3e26fc24-ba38-4df5-8524-b018042eb462" providerId="ADAL" clId="{C1599DDD-7F66-401A-A836-1FC74D5C6595}" dt="2023-11-23T09:25:31.924" v="69" actId="478"/>
          <ac:spMkLst>
            <pc:docMk/>
            <pc:sldMk cId="3246200346" sldId="260"/>
            <ac:spMk id="53" creationId="{8926A7EC-5B32-087F-526F-260F92212A12}"/>
          </ac:spMkLst>
        </pc:spChg>
        <pc:spChg chg="add mod">
          <ac:chgData name="Alejandro Jimènez Melèndez" userId="3e26fc24-ba38-4df5-8524-b018042eb462" providerId="ADAL" clId="{C1599DDD-7F66-401A-A836-1FC74D5C6595}" dt="2023-11-23T09:26:01.338" v="78" actId="1076"/>
          <ac:spMkLst>
            <pc:docMk/>
            <pc:sldMk cId="3246200346" sldId="260"/>
            <ac:spMk id="54" creationId="{FEA5119F-BCE1-BF7E-7A81-B13BE01C1E94}"/>
          </ac:spMkLst>
        </pc:spChg>
        <pc:spChg chg="add mod">
          <ac:chgData name="Alejandro Jimènez Melèndez" userId="3e26fc24-ba38-4df5-8524-b018042eb462" providerId="ADAL" clId="{C1599DDD-7F66-401A-A836-1FC74D5C6595}" dt="2023-11-23T09:26:06.211" v="79" actId="1076"/>
          <ac:spMkLst>
            <pc:docMk/>
            <pc:sldMk cId="3246200346" sldId="260"/>
            <ac:spMk id="55" creationId="{941448E3-A2BC-E895-62BE-F0DEE8FD43E1}"/>
          </ac:spMkLst>
        </pc:spChg>
      </pc:sldChg>
      <pc:sldChg chg="addSp delSp modSp del mod">
        <pc:chgData name="Alejandro Jimènez Melèndez" userId="3e26fc24-ba38-4df5-8524-b018042eb462" providerId="ADAL" clId="{C1599DDD-7F66-401A-A836-1FC74D5C6595}" dt="2023-11-23T09:03:25.739" v="61" actId="2696"/>
        <pc:sldMkLst>
          <pc:docMk/>
          <pc:sldMk cId="1651968195" sldId="261"/>
        </pc:sldMkLst>
        <pc:spChg chg="add mod">
          <ac:chgData name="Alejandro Jimènez Melèndez" userId="3e26fc24-ba38-4df5-8524-b018042eb462" providerId="ADAL" clId="{C1599DDD-7F66-401A-A836-1FC74D5C6595}" dt="2023-11-23T09:03:21.599" v="60" actId="20577"/>
          <ac:spMkLst>
            <pc:docMk/>
            <pc:sldMk cId="1651968195" sldId="261"/>
            <ac:spMk id="2" creationId="{8E8C8A21-1D14-96FB-8675-C21AABEC5075}"/>
          </ac:spMkLst>
        </pc:spChg>
        <pc:spChg chg="del">
          <ac:chgData name="Alejandro Jimènez Melèndez" userId="3e26fc24-ba38-4df5-8524-b018042eb462" providerId="ADAL" clId="{C1599DDD-7F66-401A-A836-1FC74D5C6595}" dt="2023-11-22T09:50:20.523" v="4" actId="478"/>
          <ac:spMkLst>
            <pc:docMk/>
            <pc:sldMk cId="1651968195" sldId="261"/>
            <ac:spMk id="56" creationId="{A463F7F1-15D6-A696-C532-2BB90FE4D957}"/>
          </ac:spMkLst>
        </pc:spChg>
        <pc:grpChg chg="mod">
          <ac:chgData name="Alejandro Jimènez Melèndez" userId="3e26fc24-ba38-4df5-8524-b018042eb462" providerId="ADAL" clId="{C1599DDD-7F66-401A-A836-1FC74D5C6595}" dt="2023-11-22T09:50:22.762" v="5" actId="1076"/>
          <ac:grpSpMkLst>
            <pc:docMk/>
            <pc:sldMk cId="1651968195" sldId="261"/>
            <ac:grpSpMk id="58" creationId="{CF9F715F-DEF2-64B9-4791-F5440DE4EE2B}"/>
          </ac:grpSpMkLst>
        </pc:grpChg>
        <pc:picChg chg="mod">
          <ac:chgData name="Alejandro Jimènez Melèndez" userId="3e26fc24-ba38-4df5-8524-b018042eb462" providerId="ADAL" clId="{C1599DDD-7F66-401A-A836-1FC74D5C6595}" dt="2023-11-22T09:50:24.925" v="6" actId="1076"/>
          <ac:picMkLst>
            <pc:docMk/>
            <pc:sldMk cId="1651968195" sldId="261"/>
            <ac:picMk id="59" creationId="{DEE98739-103B-B721-8580-B511D2CEF23E}"/>
          </ac:picMkLst>
        </pc:picChg>
      </pc:sldChg>
      <pc:sldChg chg="new del">
        <pc:chgData name="Alejandro Jimènez Melèndez" userId="3e26fc24-ba38-4df5-8524-b018042eb462" providerId="ADAL" clId="{C1599DDD-7F66-401A-A836-1FC74D5C6595}" dt="2023-11-23T09:03:37.050" v="63" actId="47"/>
        <pc:sldMkLst>
          <pc:docMk/>
          <pc:sldMk cId="3819315599" sldId="261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97726"/>
            <a:ext cx="15300564" cy="488794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374172"/>
            <a:ext cx="13500497" cy="3389713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328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2254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47492"/>
            <a:ext cx="3881393" cy="1189812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47492"/>
            <a:ext cx="11419171" cy="1189812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649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3423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00216"/>
            <a:ext cx="15525572" cy="5840187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395654"/>
            <a:ext cx="15525572" cy="307121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8345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737460"/>
            <a:ext cx="7650282" cy="89081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737460"/>
            <a:ext cx="7650282" cy="89081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361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47495"/>
            <a:ext cx="15525572" cy="271372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441714"/>
            <a:ext cx="7615123" cy="168673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128445"/>
            <a:ext cx="7615123" cy="75431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441714"/>
            <a:ext cx="7652626" cy="168673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128445"/>
            <a:ext cx="7652626" cy="75431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91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0112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2190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35990"/>
            <a:ext cx="5805682" cy="327596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21482"/>
            <a:ext cx="9112836" cy="997739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211955"/>
            <a:ext cx="5805682" cy="7803168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3802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35990"/>
            <a:ext cx="5805682" cy="327596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21482"/>
            <a:ext cx="9112836" cy="997739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211955"/>
            <a:ext cx="5805682" cy="7803168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623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47495"/>
            <a:ext cx="15525572" cy="2713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737460"/>
            <a:ext cx="15525572" cy="8908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012864"/>
            <a:ext cx="405014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33362F-EF41-4138-9F31-0EBDEA542876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012864"/>
            <a:ext cx="6075224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012864"/>
            <a:ext cx="405014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989632-6649-4D84-956A-0A93D682C8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4643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764CF51B-48FF-D0BF-92C8-C44B6EDF244B}"/>
              </a:ext>
            </a:extLst>
          </p:cNvPr>
          <p:cNvGrpSpPr/>
          <p:nvPr/>
        </p:nvGrpSpPr>
        <p:grpSpPr>
          <a:xfrm>
            <a:off x="1610513" y="1892133"/>
            <a:ext cx="6792686" cy="4702628"/>
            <a:chOff x="1578429" y="1086310"/>
            <a:chExt cx="6792686" cy="470262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8C553A5-B605-81DC-347F-D625B3B9B9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78429" y="1086310"/>
              <a:ext cx="6792686" cy="4702628"/>
            </a:xfrm>
            <a:prstGeom prst="rect">
              <a:avLst/>
            </a:prstGeom>
          </p:spPr>
        </p:pic>
        <p:sp>
          <p:nvSpPr>
            <p:cNvPr id="5" name="Oval 4">
              <a:extLst>
                <a:ext uri="{FF2B5EF4-FFF2-40B4-BE49-F238E27FC236}">
                  <a16:creationId xmlns:a16="http://schemas.microsoft.com/office/drawing/2014/main" id="{13663BDB-7CC5-045B-D8DA-8361173E65ED}"/>
                </a:ext>
              </a:extLst>
            </p:cNvPr>
            <p:cNvSpPr/>
            <p:nvPr/>
          </p:nvSpPr>
          <p:spPr>
            <a:xfrm>
              <a:off x="6914005" y="1675508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7039FA2B-C08B-F1C0-E0D7-B94DFEAEE9B5}"/>
                </a:ext>
              </a:extLst>
            </p:cNvPr>
            <p:cNvSpPr/>
            <p:nvPr/>
          </p:nvSpPr>
          <p:spPr>
            <a:xfrm>
              <a:off x="3873625" y="2838680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4392035C-630D-8665-8A14-CD2FD107198C}"/>
                </a:ext>
              </a:extLst>
            </p:cNvPr>
            <p:cNvSpPr/>
            <p:nvPr/>
          </p:nvSpPr>
          <p:spPr>
            <a:xfrm>
              <a:off x="5875894" y="2412407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D0BB7E11-F942-400B-999A-E467CBBE92BF}"/>
                </a:ext>
              </a:extLst>
            </p:cNvPr>
            <p:cNvSpPr/>
            <p:nvPr/>
          </p:nvSpPr>
          <p:spPr>
            <a:xfrm>
              <a:off x="5078479" y="2639663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FB134EB2-9783-2F4F-F898-0D7A4E275CB0}"/>
                </a:ext>
              </a:extLst>
            </p:cNvPr>
            <p:cNvSpPr/>
            <p:nvPr/>
          </p:nvSpPr>
          <p:spPr>
            <a:xfrm>
              <a:off x="5861101" y="2776823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A3084BFF-6E00-33F0-4473-CB0E845C5C19}"/>
                </a:ext>
              </a:extLst>
            </p:cNvPr>
            <p:cNvSpPr/>
            <p:nvPr/>
          </p:nvSpPr>
          <p:spPr>
            <a:xfrm>
              <a:off x="7726204" y="2495780"/>
              <a:ext cx="411953" cy="276999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E166E135-F40D-8A14-5406-E0A281EF01AC}"/>
                </a:ext>
              </a:extLst>
            </p:cNvPr>
            <p:cNvSpPr/>
            <p:nvPr/>
          </p:nvSpPr>
          <p:spPr>
            <a:xfrm>
              <a:off x="7021576" y="2888432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6632AAE4-034D-4DA6-EC4F-AC1B37E5146E}"/>
                </a:ext>
              </a:extLst>
            </p:cNvPr>
            <p:cNvSpPr/>
            <p:nvPr/>
          </p:nvSpPr>
          <p:spPr>
            <a:xfrm>
              <a:off x="7289173" y="2897844"/>
              <a:ext cx="304382" cy="27699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81648114-FEBE-195E-5CE5-1E9B956F44BD}"/>
                </a:ext>
              </a:extLst>
            </p:cNvPr>
            <p:cNvSpPr/>
            <p:nvPr/>
          </p:nvSpPr>
          <p:spPr>
            <a:xfrm>
              <a:off x="6990648" y="3340250"/>
              <a:ext cx="304382" cy="100848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5E2D4D3C-6B86-C121-BF4D-41B3F35C6719}"/>
                </a:ext>
              </a:extLst>
            </p:cNvPr>
            <p:cNvSpPr/>
            <p:nvPr/>
          </p:nvSpPr>
          <p:spPr>
            <a:xfrm>
              <a:off x="7008128" y="3762494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164BA99A-9543-021C-7C73-E6CE3E43354A}"/>
                </a:ext>
              </a:extLst>
            </p:cNvPr>
            <p:cNvSpPr/>
            <p:nvPr/>
          </p:nvSpPr>
          <p:spPr>
            <a:xfrm>
              <a:off x="4330824" y="4401233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87C15B5B-62CC-371E-8013-2897A2E0D090}"/>
                </a:ext>
              </a:extLst>
            </p:cNvPr>
            <p:cNvSpPr/>
            <p:nvPr/>
          </p:nvSpPr>
          <p:spPr>
            <a:xfrm>
              <a:off x="5945816" y="4975422"/>
              <a:ext cx="304382" cy="27699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7" name="Cloud 16">
              <a:extLst>
                <a:ext uri="{FF2B5EF4-FFF2-40B4-BE49-F238E27FC236}">
                  <a16:creationId xmlns:a16="http://schemas.microsoft.com/office/drawing/2014/main" id="{72AE1E5A-BFFD-19C9-E4A7-3BF80054AA03}"/>
                </a:ext>
              </a:extLst>
            </p:cNvPr>
            <p:cNvSpPr/>
            <p:nvPr/>
          </p:nvSpPr>
          <p:spPr>
            <a:xfrm>
              <a:off x="6675641" y="1459003"/>
              <a:ext cx="1300634" cy="276999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  <p:sp>
          <p:nvSpPr>
            <p:cNvPr id="18" name="Cloud 17">
              <a:extLst>
                <a:ext uri="{FF2B5EF4-FFF2-40B4-BE49-F238E27FC236}">
                  <a16:creationId xmlns:a16="http://schemas.microsoft.com/office/drawing/2014/main" id="{F96FDE19-1F6A-43F8-3D26-F9C5930BD7AA}"/>
                </a:ext>
              </a:extLst>
            </p:cNvPr>
            <p:cNvSpPr/>
            <p:nvPr/>
          </p:nvSpPr>
          <p:spPr>
            <a:xfrm>
              <a:off x="6791047" y="2785545"/>
              <a:ext cx="1300634" cy="276999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  <p:sp>
          <p:nvSpPr>
            <p:cNvPr id="19" name="Cloud 18">
              <a:extLst>
                <a:ext uri="{FF2B5EF4-FFF2-40B4-BE49-F238E27FC236}">
                  <a16:creationId xmlns:a16="http://schemas.microsoft.com/office/drawing/2014/main" id="{601B0F6B-1880-3F86-1871-CF2FFB5430B8}"/>
                </a:ext>
              </a:extLst>
            </p:cNvPr>
            <p:cNvSpPr/>
            <p:nvPr/>
          </p:nvSpPr>
          <p:spPr>
            <a:xfrm>
              <a:off x="6914006" y="3162729"/>
              <a:ext cx="573317" cy="193007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  <p:sp>
          <p:nvSpPr>
            <p:cNvPr id="20" name="Cloud 19">
              <a:extLst>
                <a:ext uri="{FF2B5EF4-FFF2-40B4-BE49-F238E27FC236}">
                  <a16:creationId xmlns:a16="http://schemas.microsoft.com/office/drawing/2014/main" id="{B3168FBF-B4F3-1792-923A-370087A5FBD6}"/>
                </a:ext>
              </a:extLst>
            </p:cNvPr>
            <p:cNvSpPr/>
            <p:nvPr/>
          </p:nvSpPr>
          <p:spPr>
            <a:xfrm>
              <a:off x="6914005" y="3607858"/>
              <a:ext cx="573317" cy="100848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1EC8A1AB-351B-CCA4-E26C-0D24011A315D}"/>
              </a:ext>
            </a:extLst>
          </p:cNvPr>
          <p:cNvGrpSpPr/>
          <p:nvPr/>
        </p:nvGrpSpPr>
        <p:grpSpPr>
          <a:xfrm>
            <a:off x="9185698" y="2127537"/>
            <a:ext cx="6448425" cy="4467225"/>
            <a:chOff x="2162679" y="1276070"/>
            <a:chExt cx="6448425" cy="4467225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5432B737-1EBD-3C1A-5779-3044013C90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62679" y="1276070"/>
              <a:ext cx="6448425" cy="4467225"/>
            </a:xfrm>
            <a:prstGeom prst="rect">
              <a:avLst/>
            </a:prstGeom>
          </p:spPr>
        </p:pic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327791B6-B41A-889B-1696-56E59EBF8635}"/>
                </a:ext>
              </a:extLst>
            </p:cNvPr>
            <p:cNvSpPr/>
            <p:nvPr/>
          </p:nvSpPr>
          <p:spPr>
            <a:xfrm>
              <a:off x="4333516" y="2919363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A58C0942-0C2A-616F-FE84-BC02346EF334}"/>
                </a:ext>
              </a:extLst>
            </p:cNvPr>
            <p:cNvSpPr/>
            <p:nvPr/>
          </p:nvSpPr>
          <p:spPr>
            <a:xfrm>
              <a:off x="6206692" y="2541500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657E0419-7A0C-65BA-7935-CEB6640AC4E9}"/>
                </a:ext>
              </a:extLst>
            </p:cNvPr>
            <p:cNvSpPr/>
            <p:nvPr/>
          </p:nvSpPr>
          <p:spPr>
            <a:xfrm>
              <a:off x="5441553" y="2728415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7F5D67C1-1521-ED6B-DDBE-9D1FF4CD0DD1}"/>
                </a:ext>
              </a:extLst>
            </p:cNvPr>
            <p:cNvSpPr/>
            <p:nvPr/>
          </p:nvSpPr>
          <p:spPr>
            <a:xfrm>
              <a:off x="7944046" y="2649077"/>
              <a:ext cx="411953" cy="276999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7" name="Oval 26">
              <a:extLst>
                <a:ext uri="{FF2B5EF4-FFF2-40B4-BE49-F238E27FC236}">
                  <a16:creationId xmlns:a16="http://schemas.microsoft.com/office/drawing/2014/main" id="{5B2761F9-D63B-2789-9FC4-E326E4802291}"/>
                </a:ext>
              </a:extLst>
            </p:cNvPr>
            <p:cNvSpPr/>
            <p:nvPr/>
          </p:nvSpPr>
          <p:spPr>
            <a:xfrm>
              <a:off x="7287831" y="2952979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978923D5-277A-2330-A15B-3AD43251E5A3}"/>
                </a:ext>
              </a:extLst>
            </p:cNvPr>
            <p:cNvSpPr/>
            <p:nvPr/>
          </p:nvSpPr>
          <p:spPr>
            <a:xfrm>
              <a:off x="7555428" y="2962391"/>
              <a:ext cx="304382" cy="27699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48FE555B-DD7A-1E27-0954-0AA95307D2A7}"/>
                </a:ext>
              </a:extLst>
            </p:cNvPr>
            <p:cNvSpPr/>
            <p:nvPr/>
          </p:nvSpPr>
          <p:spPr>
            <a:xfrm>
              <a:off x="7281106" y="3309329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10C2611E-F1E4-88F9-928A-05470A877E03}"/>
                </a:ext>
              </a:extLst>
            </p:cNvPr>
            <p:cNvSpPr/>
            <p:nvPr/>
          </p:nvSpPr>
          <p:spPr>
            <a:xfrm>
              <a:off x="7298587" y="3818974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5CF3DC56-93F3-725A-0940-21F85B6DDAD5}"/>
                </a:ext>
              </a:extLst>
            </p:cNvPr>
            <p:cNvSpPr/>
            <p:nvPr/>
          </p:nvSpPr>
          <p:spPr>
            <a:xfrm>
              <a:off x="4750373" y="4417370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966FF003-3617-6CE8-5C1D-CADB764BF446}"/>
                </a:ext>
              </a:extLst>
            </p:cNvPr>
            <p:cNvSpPr/>
            <p:nvPr/>
          </p:nvSpPr>
          <p:spPr>
            <a:xfrm>
              <a:off x="6284683" y="4975422"/>
              <a:ext cx="304382" cy="27699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b="1" dirty="0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02C24126-7CCC-0A7B-5E29-C2A45BC50BA2}"/>
                </a:ext>
              </a:extLst>
            </p:cNvPr>
            <p:cNvSpPr/>
            <p:nvPr/>
          </p:nvSpPr>
          <p:spPr>
            <a:xfrm>
              <a:off x="6240310" y="4640588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4D97AA16-3A13-C254-4A48-780E42D07F67}"/>
              </a:ext>
            </a:extLst>
          </p:cNvPr>
          <p:cNvGrpSpPr/>
          <p:nvPr/>
        </p:nvGrpSpPr>
        <p:grpSpPr>
          <a:xfrm>
            <a:off x="5188512" y="7497686"/>
            <a:ext cx="6429375" cy="4476750"/>
            <a:chOff x="5188511" y="7317505"/>
            <a:chExt cx="6429375" cy="4476750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8E1BA689-1697-BC94-3898-46824353EE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88511" y="7317505"/>
              <a:ext cx="6429375" cy="4476750"/>
            </a:xfrm>
            <a:prstGeom prst="rect">
              <a:avLst/>
            </a:prstGeom>
          </p:spPr>
        </p:pic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40AFBC00-BD39-4B04-5493-56957AF6D2FF}"/>
                </a:ext>
              </a:extLst>
            </p:cNvPr>
            <p:cNvSpPr/>
            <p:nvPr/>
          </p:nvSpPr>
          <p:spPr>
            <a:xfrm>
              <a:off x="10253513" y="7936181"/>
              <a:ext cx="391629" cy="177503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B1BC08D2-C51C-3C34-E829-DAB78AF91A1A}"/>
                </a:ext>
              </a:extLst>
            </p:cNvPr>
            <p:cNvSpPr/>
            <p:nvPr/>
          </p:nvSpPr>
          <p:spPr>
            <a:xfrm>
              <a:off x="7349820" y="9005901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E9EB9A68-7E4E-68EC-71CC-6EFC11BDCBA0}"/>
                </a:ext>
              </a:extLst>
            </p:cNvPr>
            <p:cNvSpPr/>
            <p:nvPr/>
          </p:nvSpPr>
          <p:spPr>
            <a:xfrm>
              <a:off x="9222997" y="8636106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3006F76D-12BE-1C12-3BE0-D70BBADEA5A6}"/>
                </a:ext>
              </a:extLst>
            </p:cNvPr>
            <p:cNvSpPr/>
            <p:nvPr/>
          </p:nvSpPr>
          <p:spPr>
            <a:xfrm>
              <a:off x="8457858" y="8823021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AC3B2FDD-47F3-53CA-B74E-F4CD4B1B1F9F}"/>
                </a:ext>
              </a:extLst>
            </p:cNvPr>
            <p:cNvSpPr/>
            <p:nvPr/>
          </p:nvSpPr>
          <p:spPr>
            <a:xfrm>
              <a:off x="9216272" y="8927908"/>
              <a:ext cx="411953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5E3B7E0C-167F-23A6-D540-1B3BF7A789D5}"/>
                </a:ext>
              </a:extLst>
            </p:cNvPr>
            <p:cNvSpPr/>
            <p:nvPr/>
          </p:nvSpPr>
          <p:spPr>
            <a:xfrm>
              <a:off x="10968418" y="8671069"/>
              <a:ext cx="411953" cy="276999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F089ED0A-0904-4917-A347-FEB1B3404B2D}"/>
                </a:ext>
              </a:extLst>
            </p:cNvPr>
            <p:cNvSpPr/>
            <p:nvPr/>
          </p:nvSpPr>
          <p:spPr>
            <a:xfrm>
              <a:off x="10312199" y="9015312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3" name="Oval 42">
              <a:extLst>
                <a:ext uri="{FF2B5EF4-FFF2-40B4-BE49-F238E27FC236}">
                  <a16:creationId xmlns:a16="http://schemas.microsoft.com/office/drawing/2014/main" id="{AA0BA980-5E8F-2F58-7B2B-3F8D76874DEA}"/>
                </a:ext>
              </a:extLst>
            </p:cNvPr>
            <p:cNvSpPr/>
            <p:nvPr/>
          </p:nvSpPr>
          <p:spPr>
            <a:xfrm>
              <a:off x="10579796" y="9024724"/>
              <a:ext cx="304382" cy="27699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4" name="Oval 43">
              <a:extLst>
                <a:ext uri="{FF2B5EF4-FFF2-40B4-BE49-F238E27FC236}">
                  <a16:creationId xmlns:a16="http://schemas.microsoft.com/office/drawing/2014/main" id="{F136B14D-977A-32C6-55C7-0A8996680C75}"/>
                </a:ext>
              </a:extLst>
            </p:cNvPr>
            <p:cNvSpPr/>
            <p:nvPr/>
          </p:nvSpPr>
          <p:spPr>
            <a:xfrm>
              <a:off x="10321613" y="9379729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910A41E0-F7FE-64F5-1A3A-02D61997AB5D}"/>
                </a:ext>
              </a:extLst>
            </p:cNvPr>
            <p:cNvSpPr/>
            <p:nvPr/>
          </p:nvSpPr>
          <p:spPr>
            <a:xfrm>
              <a:off x="10339093" y="9889374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227615C4-8BEE-D691-BC4B-0D74771DBCFC}"/>
                </a:ext>
              </a:extLst>
            </p:cNvPr>
            <p:cNvSpPr/>
            <p:nvPr/>
          </p:nvSpPr>
          <p:spPr>
            <a:xfrm>
              <a:off x="7774747" y="10503907"/>
              <a:ext cx="304382" cy="276999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7" name="Oval 46">
              <a:extLst>
                <a:ext uri="{FF2B5EF4-FFF2-40B4-BE49-F238E27FC236}">
                  <a16:creationId xmlns:a16="http://schemas.microsoft.com/office/drawing/2014/main" id="{0B6F4B3D-4A08-B85A-96CB-63037BFEB5C3}"/>
                </a:ext>
              </a:extLst>
            </p:cNvPr>
            <p:cNvSpPr/>
            <p:nvPr/>
          </p:nvSpPr>
          <p:spPr>
            <a:xfrm>
              <a:off x="9309054" y="11021619"/>
              <a:ext cx="304382" cy="276999"/>
            </a:xfrm>
            <a:prstGeom prst="ellipse">
              <a:avLst/>
            </a:prstGeom>
            <a:noFill/>
            <a:ln w="2540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412F99D1-65FA-B1AA-F7B0-F20024D775BB}"/>
                </a:ext>
              </a:extLst>
            </p:cNvPr>
            <p:cNvSpPr/>
            <p:nvPr/>
          </p:nvSpPr>
          <p:spPr>
            <a:xfrm>
              <a:off x="9256614" y="10727126"/>
              <a:ext cx="411953" cy="276999"/>
            </a:xfrm>
            <a:prstGeom prst="ellipse">
              <a:avLst/>
            </a:prstGeom>
            <a:noFill/>
            <a:ln w="25400">
              <a:solidFill>
                <a:schemeClr val="accent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49" name="Cloud 48">
              <a:extLst>
                <a:ext uri="{FF2B5EF4-FFF2-40B4-BE49-F238E27FC236}">
                  <a16:creationId xmlns:a16="http://schemas.microsoft.com/office/drawing/2014/main" id="{A2D4159C-609C-32FC-C283-AF85691EC157}"/>
                </a:ext>
              </a:extLst>
            </p:cNvPr>
            <p:cNvSpPr/>
            <p:nvPr/>
          </p:nvSpPr>
          <p:spPr>
            <a:xfrm>
              <a:off x="10321612" y="7753856"/>
              <a:ext cx="573317" cy="193007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  <p:sp>
          <p:nvSpPr>
            <p:cNvPr id="50" name="Cloud 49">
              <a:extLst>
                <a:ext uri="{FF2B5EF4-FFF2-40B4-BE49-F238E27FC236}">
                  <a16:creationId xmlns:a16="http://schemas.microsoft.com/office/drawing/2014/main" id="{7F7F6D0B-5702-A449-F117-37487D3939BA}"/>
                </a:ext>
              </a:extLst>
            </p:cNvPr>
            <p:cNvSpPr/>
            <p:nvPr/>
          </p:nvSpPr>
          <p:spPr>
            <a:xfrm>
              <a:off x="10293137" y="8650907"/>
              <a:ext cx="807541" cy="177503"/>
            </a:xfrm>
            <a:prstGeom prst="cloud">
              <a:avLst/>
            </a:prstGeom>
            <a:noFill/>
            <a:ln w="349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B79A0502-A30B-49C2-92DE-44A96E049F78}"/>
              </a:ext>
            </a:extLst>
          </p:cNvPr>
          <p:cNvSpPr txBox="1"/>
          <p:nvPr/>
        </p:nvSpPr>
        <p:spPr>
          <a:xfrm>
            <a:off x="261371" y="226345"/>
            <a:ext cx="15481630" cy="12578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Supplementary figure 5: Tumour necrosis factor alpha (TNF</a:t>
            </a:r>
            <a:r>
              <a:rPr lang="el-GR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α</a:t>
            </a:r>
            <a:r>
              <a:rPr lang="en-US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) K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EGG pathway 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1800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A)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C)Co-expos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b="1" dirty="0">
                <a:latin typeface="Times New Roman"/>
                <a:ea typeface="Times New Roman" panose="02020603050405020304" pitchFamily="18" charset="0"/>
                <a:cs typeface="Arial"/>
              </a:rPr>
              <a:t>.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Outline in blue is used to indicate that the gene is upregulated i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red in co-exposed cells and green in both single infections (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1800" b="1" i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) but not in co-exposed.</a:t>
            </a:r>
            <a:endParaRPr lang="nb-NO" sz="1600" b="1" dirty="0">
              <a:effectLst/>
              <a:latin typeface="Times New Roman"/>
              <a:ea typeface="Calibri" panose="020F0502020204030204" pitchFamily="34" charset="0"/>
              <a:cs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F4E425C-AB48-6285-9AA6-7AF824ED8798}"/>
              </a:ext>
            </a:extLst>
          </p:cNvPr>
          <p:cNvSpPr txBox="1"/>
          <p:nvPr/>
        </p:nvSpPr>
        <p:spPr>
          <a:xfrm>
            <a:off x="1570892" y="1604324"/>
            <a:ext cx="949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EA5119F-BCE1-BF7E-7A81-B13BE01C1E94}"/>
              </a:ext>
            </a:extLst>
          </p:cNvPr>
          <p:cNvSpPr txBox="1"/>
          <p:nvPr/>
        </p:nvSpPr>
        <p:spPr>
          <a:xfrm>
            <a:off x="9160166" y="1604324"/>
            <a:ext cx="949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41448E3-A2BC-E895-62BE-F0DEE8FD43E1}"/>
              </a:ext>
            </a:extLst>
          </p:cNvPr>
          <p:cNvSpPr txBox="1"/>
          <p:nvPr/>
        </p:nvSpPr>
        <p:spPr>
          <a:xfrm>
            <a:off x="4958408" y="7186229"/>
            <a:ext cx="9495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246200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47</TotalTime>
  <Words>11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09-26T07:37:51Z</dcterms:created>
  <dcterms:modified xsi:type="dcterms:W3CDTF">2023-11-23T09:26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09-26T07:38:18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cdc87955-a131-4fb6-ad54-ea65b3102631</vt:lpwstr>
  </property>
  <property fmtid="{D5CDD505-2E9C-101B-9397-08002B2CF9AE}" pid="8" name="MSIP_Label_d0484126-3486-41a9-802e-7f1e2277276c_ContentBits">
    <vt:lpwstr>0</vt:lpwstr>
  </property>
</Properties>
</file>